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735763" cy="98663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1" autoAdjust="0"/>
    <p:restoredTop sz="94660"/>
  </p:normalViewPr>
  <p:slideViewPr>
    <p:cSldViewPr snapToGrid="0" showGuides="1">
      <p:cViewPr varScale="1">
        <p:scale>
          <a:sx n="131" d="100"/>
          <a:sy n="131" d="100"/>
        </p:scale>
        <p:origin x="1336" y="1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A8FE-4C4B-44A2-B58E-881895AA92AA}" type="datetimeFigureOut">
              <a:rPr lang="de-DE" smtClean="0"/>
              <a:t>17.03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4924-F5B6-46AC-A9DD-49A27CCD6E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2457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A8FE-4C4B-44A2-B58E-881895AA92AA}" type="datetimeFigureOut">
              <a:rPr lang="de-DE" smtClean="0"/>
              <a:t>17.03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4924-F5B6-46AC-A9DD-49A27CCD6E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1938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A8FE-4C4B-44A2-B58E-881895AA92AA}" type="datetimeFigureOut">
              <a:rPr lang="de-DE" smtClean="0"/>
              <a:t>17.03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4924-F5B6-46AC-A9DD-49A27CCD6E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24826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A8FE-4C4B-44A2-B58E-881895AA92AA}" type="datetimeFigureOut">
              <a:rPr lang="de-DE" smtClean="0"/>
              <a:t>17.03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4924-F5B6-46AC-A9DD-49A27CCD6E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3300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A8FE-4C4B-44A2-B58E-881895AA92AA}" type="datetimeFigureOut">
              <a:rPr lang="de-DE" smtClean="0"/>
              <a:t>17.03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4924-F5B6-46AC-A9DD-49A27CCD6E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0784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A8FE-4C4B-44A2-B58E-881895AA92AA}" type="datetimeFigureOut">
              <a:rPr lang="de-DE" smtClean="0"/>
              <a:t>17.03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4924-F5B6-46AC-A9DD-49A27CCD6E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60065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A8FE-4C4B-44A2-B58E-881895AA92AA}" type="datetimeFigureOut">
              <a:rPr lang="de-DE" smtClean="0"/>
              <a:t>17.03.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4924-F5B6-46AC-A9DD-49A27CCD6E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81375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A8FE-4C4B-44A2-B58E-881895AA92AA}" type="datetimeFigureOut">
              <a:rPr lang="de-DE" smtClean="0"/>
              <a:t>17.03.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4924-F5B6-46AC-A9DD-49A27CCD6E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5884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A8FE-4C4B-44A2-B58E-881895AA92AA}" type="datetimeFigureOut">
              <a:rPr lang="de-DE" smtClean="0"/>
              <a:t>17.03.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4924-F5B6-46AC-A9DD-49A27CCD6E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97426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A8FE-4C4B-44A2-B58E-881895AA92AA}" type="datetimeFigureOut">
              <a:rPr lang="de-DE" smtClean="0"/>
              <a:t>17.03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4924-F5B6-46AC-A9DD-49A27CCD6E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8411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95A8FE-4C4B-44A2-B58E-881895AA92AA}" type="datetimeFigureOut">
              <a:rPr lang="de-DE" smtClean="0"/>
              <a:t>17.03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D04924-F5B6-46AC-A9DD-49A27CCD6E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2751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95A8FE-4C4B-44A2-B58E-881895AA92AA}" type="datetimeFigureOut">
              <a:rPr lang="de-DE" smtClean="0"/>
              <a:t>17.03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D04924-F5B6-46AC-A9DD-49A27CCD6E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387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feld 34"/>
          <p:cNvSpPr txBox="1"/>
          <p:nvPr/>
        </p:nvSpPr>
        <p:spPr>
          <a:xfrm>
            <a:off x="6475986" y="1767322"/>
            <a:ext cx="2417860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, ECL,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1 min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: FXII -/- Plasma 1 µl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2: FXII -/- Plasma 0.3 µl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3: WT Plasma 0.3 µl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4: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+ 1 µl WT Plasma</a:t>
            </a:r>
          </a:p>
          <a:p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mbran 1: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First AB: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GAHu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XII (Nordic)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econd AB: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Rabbit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Goat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HRP 1:10000</a:t>
            </a:r>
          </a:p>
          <a:p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mbran 2: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First AB: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Supernatant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Biogenes 27-1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econd AB: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Rabbit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-mouse HRP 1:1000</a:t>
            </a:r>
          </a:p>
          <a:p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mbran 3: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First AB: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Supernatant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Biogenes Neg.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econd AB: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Rabbit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-mouse HRP 1:1000</a:t>
            </a:r>
          </a:p>
          <a:p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mbran 4: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First AB: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Supernatant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Biogenes 37-4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econd AB: 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Rabbit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-mouse HRP 1:1000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350470" y="1946051"/>
            <a:ext cx="3714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359985" y="2242823"/>
            <a:ext cx="3714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364343" y="2447623"/>
            <a:ext cx="3714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397975" y="2581366"/>
            <a:ext cx="3714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408110" y="2781092"/>
            <a:ext cx="3714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397977" y="3011921"/>
            <a:ext cx="3714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8" name="Textfeld 27"/>
          <p:cNvSpPr txBox="1"/>
          <p:nvPr/>
        </p:nvSpPr>
        <p:spPr>
          <a:xfrm>
            <a:off x="939863" y="1824428"/>
            <a:ext cx="269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9" name="Textfeld 28"/>
          <p:cNvSpPr txBox="1"/>
          <p:nvPr/>
        </p:nvSpPr>
        <p:spPr>
          <a:xfrm>
            <a:off x="1190119" y="1826949"/>
            <a:ext cx="269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0" name="Textfeld 29"/>
          <p:cNvSpPr txBox="1"/>
          <p:nvPr/>
        </p:nvSpPr>
        <p:spPr>
          <a:xfrm>
            <a:off x="1475636" y="1830726"/>
            <a:ext cx="269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1" name="Textfeld 30"/>
          <p:cNvSpPr txBox="1"/>
          <p:nvPr/>
        </p:nvSpPr>
        <p:spPr>
          <a:xfrm>
            <a:off x="1779886" y="1826950"/>
            <a:ext cx="269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2" name="Textfeld 31"/>
          <p:cNvSpPr txBox="1"/>
          <p:nvPr/>
        </p:nvSpPr>
        <p:spPr>
          <a:xfrm>
            <a:off x="2346168" y="1825346"/>
            <a:ext cx="269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2642951" y="1824428"/>
            <a:ext cx="269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9" name="Textfeld 38"/>
          <p:cNvSpPr txBox="1"/>
          <p:nvPr/>
        </p:nvSpPr>
        <p:spPr>
          <a:xfrm>
            <a:off x="408110" y="3221903"/>
            <a:ext cx="3714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41" name="Textfeld 40"/>
          <p:cNvSpPr txBox="1"/>
          <p:nvPr/>
        </p:nvSpPr>
        <p:spPr>
          <a:xfrm>
            <a:off x="416130" y="3489806"/>
            <a:ext cx="3714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46" name="Textfeld 45"/>
          <p:cNvSpPr txBox="1"/>
          <p:nvPr/>
        </p:nvSpPr>
        <p:spPr>
          <a:xfrm>
            <a:off x="406505" y="3932566"/>
            <a:ext cx="3714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88" name="Textfeld 87"/>
          <p:cNvSpPr txBox="1"/>
          <p:nvPr/>
        </p:nvSpPr>
        <p:spPr>
          <a:xfrm>
            <a:off x="1248003" y="4102411"/>
            <a:ext cx="269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9" name="Textfeld 88"/>
          <p:cNvSpPr txBox="1"/>
          <p:nvPr/>
        </p:nvSpPr>
        <p:spPr>
          <a:xfrm>
            <a:off x="2593939" y="4100809"/>
            <a:ext cx="269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93" t="5843" r="43481" b="56696"/>
          <a:stretch/>
        </p:blipFill>
        <p:spPr>
          <a:xfrm>
            <a:off x="623798" y="2066734"/>
            <a:ext cx="2666199" cy="2059807"/>
          </a:xfrm>
          <a:prstGeom prst="rect">
            <a:avLst/>
          </a:prstGeom>
        </p:spPr>
      </p:pic>
      <p:sp>
        <p:nvSpPr>
          <p:cNvPr id="53" name="Textfeld 52"/>
          <p:cNvSpPr txBox="1"/>
          <p:nvPr/>
        </p:nvSpPr>
        <p:spPr>
          <a:xfrm>
            <a:off x="2949356" y="1832448"/>
            <a:ext cx="269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7" name="Rechteck 6"/>
          <p:cNvSpPr/>
          <p:nvPr/>
        </p:nvSpPr>
        <p:spPr>
          <a:xfrm>
            <a:off x="623798" y="1797566"/>
            <a:ext cx="1425595" cy="25186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5" name="Rechteck 54"/>
          <p:cNvSpPr/>
          <p:nvPr/>
        </p:nvSpPr>
        <p:spPr>
          <a:xfrm>
            <a:off x="2095212" y="1796197"/>
            <a:ext cx="1194786" cy="25186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1" name="Textfeld 90"/>
          <p:cNvSpPr txBox="1"/>
          <p:nvPr/>
        </p:nvSpPr>
        <p:spPr>
          <a:xfrm>
            <a:off x="4507934" y="4101057"/>
            <a:ext cx="269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92" name="Textfeld 91"/>
          <p:cNvSpPr txBox="1"/>
          <p:nvPr/>
        </p:nvSpPr>
        <p:spPr>
          <a:xfrm>
            <a:off x="5689255" y="4107980"/>
            <a:ext cx="269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89" t="46179" r="43916" b="17109"/>
          <a:stretch/>
        </p:blipFill>
        <p:spPr>
          <a:xfrm>
            <a:off x="5203241" y="2066734"/>
            <a:ext cx="1169169" cy="2018720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pic>
        <p:nvPicPr>
          <p:cNvPr id="58" name="Grafik 5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32" t="46179" r="61202" b="17109"/>
          <a:stretch/>
        </p:blipFill>
        <p:spPr>
          <a:xfrm>
            <a:off x="3807873" y="2064049"/>
            <a:ext cx="1373230" cy="2018720"/>
          </a:xfrm>
          <a:prstGeom prst="rect">
            <a:avLst/>
          </a:prstGeom>
          <a:scene3d>
            <a:camera prst="orthographicFront">
              <a:rot lat="0" lon="10800000" rev="0"/>
            </a:camera>
            <a:lightRig rig="threePt" dir="t"/>
          </a:scene3d>
        </p:spPr>
      </p:pic>
      <p:sp>
        <p:nvSpPr>
          <p:cNvPr id="59" name="Textfeld 58"/>
          <p:cNvSpPr txBox="1"/>
          <p:nvPr/>
        </p:nvSpPr>
        <p:spPr>
          <a:xfrm>
            <a:off x="3544459" y="2002200"/>
            <a:ext cx="3714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3553974" y="2183470"/>
            <a:ext cx="3714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</p:txBody>
      </p:sp>
      <p:sp>
        <p:nvSpPr>
          <p:cNvPr id="61" name="Textfeld 60"/>
          <p:cNvSpPr txBox="1"/>
          <p:nvPr/>
        </p:nvSpPr>
        <p:spPr>
          <a:xfrm>
            <a:off x="3558332" y="2340141"/>
            <a:ext cx="3714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77" name="Textfeld 76"/>
          <p:cNvSpPr txBox="1"/>
          <p:nvPr/>
        </p:nvSpPr>
        <p:spPr>
          <a:xfrm>
            <a:off x="3591964" y="2435384"/>
            <a:ext cx="3714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78" name="Textfeld 77"/>
          <p:cNvSpPr txBox="1"/>
          <p:nvPr/>
        </p:nvSpPr>
        <p:spPr>
          <a:xfrm>
            <a:off x="3602099" y="2635110"/>
            <a:ext cx="3714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79" name="Textfeld 78"/>
          <p:cNvSpPr txBox="1"/>
          <p:nvPr/>
        </p:nvSpPr>
        <p:spPr>
          <a:xfrm>
            <a:off x="3591966" y="2865939"/>
            <a:ext cx="3714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80" name="Textfeld 79"/>
          <p:cNvSpPr txBox="1"/>
          <p:nvPr/>
        </p:nvSpPr>
        <p:spPr>
          <a:xfrm>
            <a:off x="3602099" y="3075921"/>
            <a:ext cx="3714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81" name="Textfeld 80"/>
          <p:cNvSpPr txBox="1"/>
          <p:nvPr/>
        </p:nvSpPr>
        <p:spPr>
          <a:xfrm>
            <a:off x="3610119" y="3276448"/>
            <a:ext cx="3714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82" name="Textfeld 81"/>
          <p:cNvSpPr txBox="1"/>
          <p:nvPr/>
        </p:nvSpPr>
        <p:spPr>
          <a:xfrm>
            <a:off x="3600494" y="3709583"/>
            <a:ext cx="3714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95" name="Textfeld 94"/>
          <p:cNvSpPr txBox="1"/>
          <p:nvPr/>
        </p:nvSpPr>
        <p:spPr>
          <a:xfrm>
            <a:off x="4085724" y="1832451"/>
            <a:ext cx="269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96" name="Textfeld 95"/>
          <p:cNvSpPr txBox="1"/>
          <p:nvPr/>
        </p:nvSpPr>
        <p:spPr>
          <a:xfrm>
            <a:off x="4335980" y="1834972"/>
            <a:ext cx="269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97" name="Textfeld 96"/>
          <p:cNvSpPr txBox="1"/>
          <p:nvPr/>
        </p:nvSpPr>
        <p:spPr>
          <a:xfrm>
            <a:off x="4621497" y="1838749"/>
            <a:ext cx="269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98" name="Textfeld 97"/>
          <p:cNvSpPr txBox="1"/>
          <p:nvPr/>
        </p:nvSpPr>
        <p:spPr>
          <a:xfrm>
            <a:off x="4925747" y="1834973"/>
            <a:ext cx="269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99" name="Textfeld 98"/>
          <p:cNvSpPr txBox="1"/>
          <p:nvPr/>
        </p:nvSpPr>
        <p:spPr>
          <a:xfrm>
            <a:off x="5492029" y="1833369"/>
            <a:ext cx="269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0" name="Textfeld 99"/>
          <p:cNvSpPr txBox="1"/>
          <p:nvPr/>
        </p:nvSpPr>
        <p:spPr>
          <a:xfrm>
            <a:off x="5788812" y="1832451"/>
            <a:ext cx="269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01" name="Textfeld 100"/>
          <p:cNvSpPr txBox="1"/>
          <p:nvPr/>
        </p:nvSpPr>
        <p:spPr>
          <a:xfrm>
            <a:off x="6095217" y="1840471"/>
            <a:ext cx="2695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02" name="Rechteck 101"/>
          <p:cNvSpPr/>
          <p:nvPr/>
        </p:nvSpPr>
        <p:spPr>
          <a:xfrm>
            <a:off x="3788915" y="1805589"/>
            <a:ext cx="1425595" cy="25186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3" name="Rechteck 102"/>
          <p:cNvSpPr/>
          <p:nvPr/>
        </p:nvSpPr>
        <p:spPr>
          <a:xfrm>
            <a:off x="5221829" y="1804220"/>
            <a:ext cx="1150581" cy="25186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" name="Rectangle 1"/>
          <p:cNvSpPr/>
          <p:nvPr/>
        </p:nvSpPr>
        <p:spPr>
          <a:xfrm>
            <a:off x="2275214" y="2197677"/>
            <a:ext cx="1014784" cy="1734889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3" name="Rectangle 92"/>
          <p:cNvSpPr/>
          <p:nvPr/>
        </p:nvSpPr>
        <p:spPr>
          <a:xfrm>
            <a:off x="5445093" y="2214661"/>
            <a:ext cx="953893" cy="1868108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4" name="Rectangle 93"/>
          <p:cNvSpPr/>
          <p:nvPr/>
        </p:nvSpPr>
        <p:spPr>
          <a:xfrm>
            <a:off x="4067016" y="2208006"/>
            <a:ext cx="953893" cy="1868108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9CC018BB-727C-FC47-9DAC-8D35A331FCC9}"/>
              </a:ext>
            </a:extLst>
          </p:cNvPr>
          <p:cNvSpPr txBox="1"/>
          <p:nvPr/>
        </p:nvSpPr>
        <p:spPr>
          <a:xfrm>
            <a:off x="483239" y="573932"/>
            <a:ext cx="1061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Figure</a:t>
            </a:r>
            <a:r>
              <a:rPr lang="de-DE" dirty="0"/>
              <a:t> 7B</a:t>
            </a:r>
          </a:p>
        </p:txBody>
      </p:sp>
    </p:spTree>
    <p:extLst>
      <p:ext uri="{BB962C8B-B14F-4D97-AF65-F5344CB8AC3E}">
        <p14:creationId xmlns:p14="http://schemas.microsoft.com/office/powerpoint/2010/main" val="5989318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7</Words>
  <Application>Microsoft Macintosh PowerPoint</Application>
  <PresentationFormat>Bildschirmpräsentation (4:3)</PresentationFormat>
  <Paragraphs>58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enri</dc:creator>
  <cp:lastModifiedBy>Thomas Renné</cp:lastModifiedBy>
  <cp:revision>33</cp:revision>
  <cp:lastPrinted>2018-01-08T10:50:00Z</cp:lastPrinted>
  <dcterms:created xsi:type="dcterms:W3CDTF">2017-12-04T11:13:44Z</dcterms:created>
  <dcterms:modified xsi:type="dcterms:W3CDTF">2021-03-17T17:55:24Z</dcterms:modified>
</cp:coreProperties>
</file>